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61" r:id="rId3"/>
    <p:sldId id="262" r:id="rId4"/>
    <p:sldId id="263" r:id="rId5"/>
    <p:sldId id="257" r:id="rId6"/>
    <p:sldId id="258" r:id="rId7"/>
    <p:sldId id="259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A96E0F2-E9FF-4AA3-B9FC-40EDD36ED6E3}" v="1" dt="2022-06-20T11:12:50.5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56"/>
  </p:normalViewPr>
  <p:slideViewPr>
    <p:cSldViewPr snapToGrid="0" snapToObjects="1">
      <p:cViewPr varScale="1">
        <p:scale>
          <a:sx n="104" d="100"/>
          <a:sy n="104" d="100"/>
        </p:scale>
        <p:origin x="22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ice Coles-Aldridge" userId="d6d9cfeb-6095-46d4-99db-674d064b3bd4" providerId="ADAL" clId="{6A96E0F2-E9FF-4AA3-B9FC-40EDD36ED6E3}"/>
    <pc:docChg chg="addSld modSld">
      <pc:chgData name="Alice Coles-Aldridge" userId="d6d9cfeb-6095-46d4-99db-674d064b3bd4" providerId="ADAL" clId="{6A96E0F2-E9FF-4AA3-B9FC-40EDD36ED6E3}" dt="2022-06-20T11:12:50.581" v="0"/>
      <pc:docMkLst>
        <pc:docMk/>
      </pc:docMkLst>
      <pc:sldChg chg="add">
        <pc:chgData name="Alice Coles-Aldridge" userId="d6d9cfeb-6095-46d4-99db-674d064b3bd4" providerId="ADAL" clId="{6A96E0F2-E9FF-4AA3-B9FC-40EDD36ED6E3}" dt="2022-06-20T11:12:50.581" v="0"/>
        <pc:sldMkLst>
          <pc:docMk/>
          <pc:sldMk cId="2603979768" sldId="263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0CA8EB-BF0E-564D-9D2A-FB23806BFB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2A6DBC-EB02-AB4A-8309-6B94C33489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A80E53-582A-134B-A394-2EEF93923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F4EA6B-D65B-6A43-A6B4-ACABBEB5E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C56C68-DB36-AB46-9F2B-D301FAB52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502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169607-1AEE-0844-B250-ADED417127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9A42B7-DA1A-9A45-AA6C-C91E5F8D06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8374EF-0609-F049-AFFA-44ECFA30C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F0B7D-8D18-0E4B-835D-B6DD2E524C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AE2488-2D4C-884B-9268-B769DE663C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894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41A161-E630-C749-8387-C3E94BBD79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2AC176-3C2B-BA4D-8B26-D4043AA70E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546F35-9E41-6240-B723-14EBF9083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B98366-C231-7641-BA35-52BA3E416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B96680-8A49-4242-A099-62BB9F5E3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223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A7FB97-4E11-5D4F-AA93-8DD911C0D9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9495C9-3FDE-7846-933C-920631189D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8A7758-EF9F-E04F-B303-C2E295C277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561E6B-586E-9846-8DBF-AF2CF2BC8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FE17F1-C6B0-4C4C-96F3-78B16B652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089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4B9D7A-5F1B-E046-853A-D46D1DEB9E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0859DB-5E01-FD43-9314-84B18EAC34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90FD61-98CC-5646-8467-CB438557D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53BCE9-302D-2A4A-A82D-845930D62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718F9F-5CB2-9A45-8264-6258AD509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033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BBD107-4A64-694B-B52E-F10CD8DCE2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5487C8-D50F-2247-A437-33A604D4F5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03400E-6F24-8640-9FE9-AC05C17C50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040657-990A-DD45-BDD7-C25C950B4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CCC301-8A1D-434C-BBF1-2F8CCF306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467D39-EE58-2F48-9E17-3B829E1FD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085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49B4BF-0141-BA49-BBA2-A890FDC9D1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6BB555-D5A3-7846-9B17-20D728D326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8C30A3-B336-A24F-A082-1CF1E9904A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C86472E-72B9-8C49-9098-EF67B2719A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B7999C-127C-D846-93B9-D12982EB2A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DB6D571-5762-9F4F-BAAA-1FADCE680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49AD189-FF36-3745-9E4C-62D0C978F1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E490D55-0C14-C24B-91F6-0909B99E6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356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581B4-6798-374C-9B78-3719DD172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E27B41-C267-CD48-B875-08BB3F153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211B147-FDEC-F547-9292-DB3BEF213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494B804-C674-5E48-B4CF-816F313674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2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104011-4682-AB46-8A15-83FB42FC8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1D8B28-6B61-C446-AF8F-1BF85BEFF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758CCC-D531-784C-B998-6544672DD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64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822D2-E87F-1E47-BA41-7B020EB9AE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0BED4C-4B7A-3B49-A0CE-4E9EFEE30B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2CE12A-3E69-D14A-B827-62C1794C49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3AB8D4-C3F3-D040-AE43-AB9C7886B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4CBB3F-01FD-4B45-A336-A5A8D9675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D85736-6414-7E43-AD7A-AC1EB517D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765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FCCE45-4249-5A4A-B6F4-D49772DB1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97CF0EC-A2A9-5943-B1DC-28B9CE9B57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652BB0-BB7D-3149-A7D6-1C18099A55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9D4D00-9745-EE4C-9C89-57195B28B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FE5B25-34C8-F04F-BCC5-1F6046721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596E1A-248B-9C43-AA7B-81634E961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813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2707C5-1999-724B-8F14-473624153F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2B1040-1C37-6542-9DC0-E6D9C1F11B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6C4D9E-53C4-094A-97D6-2207CAE76D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CF9693-17BB-1346-9B4F-0AA69D85A9F7}" type="datetimeFigureOut">
              <a:rPr lang="en-US" smtClean="0"/>
              <a:t>6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2DFC05-90AB-3D45-82CF-9008B07B09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922E4D-D651-1643-88C0-47ECA3E6AC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E7D9F-8D8D-554F-A2AD-401D623EB0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671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3">
            <a:extLst>
              <a:ext uri="{FF2B5EF4-FFF2-40B4-BE49-F238E27FC236}">
                <a16:creationId xmlns:a16="http://schemas.microsoft.com/office/drawing/2014/main" id="{A732D1A4-39F5-CE48-90D6-76A8057FEE8E}"/>
              </a:ext>
            </a:extLst>
          </p:cNvPr>
          <p:cNvSpPr txBox="1">
            <a:spLocks noChangeArrowheads="1"/>
          </p:cNvSpPr>
          <p:nvPr/>
        </p:nvSpPr>
        <p:spPr>
          <a:xfrm>
            <a:off x="355600" y="279400"/>
            <a:ext cx="9359900" cy="457200"/>
          </a:xfrm>
          <a:prstGeom prst="rect">
            <a:avLst/>
          </a:prstGeom>
          <a:noFill/>
          <a:ln/>
        </p:spPr>
        <p:txBody>
          <a:bodyPr vert="horz" lIns="91440" tIns="45720" rIns="91440" bIns="45720" rtlCol="0">
            <a:sp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spcBef>
                <a:spcPct val="0"/>
              </a:spcBef>
              <a:buFontTx/>
              <a:buNone/>
            </a:pPr>
            <a:r>
              <a:rPr lang="en-US" altLang="en-US" sz="1600" b="1">
                <a:solidFill>
                  <a:schemeClr val="tx2"/>
                </a:solidFill>
              </a:rPr>
              <a:t>Figure 5. β-catenin signalling enhances SATB1 binding on its targets in vivo.</a:t>
            </a:r>
          </a:p>
        </p:txBody>
      </p:sp>
      <p:pic>
        <p:nvPicPr>
          <p:cNvPr id="6" name="Picture 2">
            <a:extLst>
              <a:ext uri="{FF2B5EF4-FFF2-40B4-BE49-F238E27FC236}">
                <a16:creationId xmlns:a16="http://schemas.microsoft.com/office/drawing/2014/main" id="{D8601307-C767-564A-9200-9B356F2F62B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300" y="863600"/>
            <a:ext cx="44831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34719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2304EACF-69B9-A543-B5A8-F53C28F7CAD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256" b="64226"/>
          <a:stretch/>
        </p:blipFill>
        <p:spPr bwMode="auto">
          <a:xfrm>
            <a:off x="750620" y="1635496"/>
            <a:ext cx="4254032" cy="3744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9BB67D3-3E75-0B45-8708-BD6074B2BB4E}"/>
              </a:ext>
            </a:extLst>
          </p:cNvPr>
          <p:cNvSpPr txBox="1"/>
          <p:nvPr/>
        </p:nvSpPr>
        <p:spPr>
          <a:xfrm>
            <a:off x="501040" y="275573"/>
            <a:ext cx="17987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5A Top panel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965F5BE-DCA3-674D-9FB3-B19A9115C2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6839885" y="263371"/>
            <a:ext cx="4038075" cy="6194227"/>
          </a:xfrm>
          <a:prstGeom prst="rect">
            <a:avLst/>
          </a:prstGeom>
        </p:spPr>
      </p:pic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62076E80-C51A-A349-821A-18E14762DBC3}"/>
              </a:ext>
            </a:extLst>
          </p:cNvPr>
          <p:cNvCxnSpPr/>
          <p:nvPr/>
        </p:nvCxnSpPr>
        <p:spPr>
          <a:xfrm flipV="1">
            <a:off x="4227616" y="2066306"/>
            <a:ext cx="2766950" cy="201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9BBCA0D3-4F52-4A4A-AF1C-E026AADE69E8}"/>
              </a:ext>
            </a:extLst>
          </p:cNvPr>
          <p:cNvCxnSpPr>
            <a:cxnSpLocks/>
          </p:cNvCxnSpPr>
          <p:nvPr/>
        </p:nvCxnSpPr>
        <p:spPr>
          <a:xfrm>
            <a:off x="4227616" y="2698997"/>
            <a:ext cx="2648197" cy="1510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302AC15C-351E-A846-B206-75D890A8767E}"/>
              </a:ext>
            </a:extLst>
          </p:cNvPr>
          <p:cNvCxnSpPr>
            <a:cxnSpLocks/>
          </p:cNvCxnSpPr>
          <p:nvPr/>
        </p:nvCxnSpPr>
        <p:spPr>
          <a:xfrm>
            <a:off x="4227616" y="3258779"/>
            <a:ext cx="2648197" cy="5818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034872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EEDB2312-BF6E-B848-9C12-160920701CB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256" b="64226"/>
          <a:stretch/>
        </p:blipFill>
        <p:spPr bwMode="auto">
          <a:xfrm>
            <a:off x="323109" y="1635496"/>
            <a:ext cx="4254032" cy="3744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E466A02-8FEE-3A4B-9C35-2CC515EA7D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7325812" y="701526"/>
            <a:ext cx="4014243" cy="5341748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4F7DD27F-1233-0640-A8D6-B104D9DB04BF}"/>
              </a:ext>
            </a:extLst>
          </p:cNvPr>
          <p:cNvCxnSpPr>
            <a:cxnSpLocks/>
          </p:cNvCxnSpPr>
          <p:nvPr/>
        </p:nvCxnSpPr>
        <p:spPr>
          <a:xfrm flipV="1">
            <a:off x="3859481" y="4227616"/>
            <a:ext cx="2802578" cy="57001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0E937CBA-FAA4-3A4C-BE58-EE35C8D0D0F2}"/>
              </a:ext>
            </a:extLst>
          </p:cNvPr>
          <p:cNvCxnSpPr>
            <a:cxnSpLocks/>
          </p:cNvCxnSpPr>
          <p:nvPr/>
        </p:nvCxnSpPr>
        <p:spPr>
          <a:xfrm flipV="1">
            <a:off x="3853544" y="3372400"/>
            <a:ext cx="3651661" cy="90747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5B8E29D-5ABA-064C-B4AE-FA379F29FD8E}"/>
              </a:ext>
            </a:extLst>
          </p:cNvPr>
          <p:cNvCxnSpPr>
            <a:cxnSpLocks/>
          </p:cNvCxnSpPr>
          <p:nvPr/>
        </p:nvCxnSpPr>
        <p:spPr>
          <a:xfrm flipV="1">
            <a:off x="3834934" y="2267899"/>
            <a:ext cx="3955279" cy="15428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80DCCB03-BDA7-9346-9E24-D8A37B51B5A3}"/>
              </a:ext>
            </a:extLst>
          </p:cNvPr>
          <p:cNvSpPr txBox="1"/>
          <p:nvPr/>
        </p:nvSpPr>
        <p:spPr>
          <a:xfrm>
            <a:off x="501040" y="275573"/>
            <a:ext cx="22852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5A Bottom panel</a:t>
            </a:r>
          </a:p>
        </p:txBody>
      </p:sp>
    </p:spTree>
    <p:extLst>
      <p:ext uri="{BB962C8B-B14F-4D97-AF65-F5344CB8AC3E}">
        <p14:creationId xmlns:p14="http://schemas.microsoft.com/office/powerpoint/2010/main" val="26767178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8634848-FCD5-9649-8F57-8BBA4BB5DF0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2727" b="34026"/>
          <a:stretch/>
        </p:blipFill>
        <p:spPr>
          <a:xfrm>
            <a:off x="5341057" y="510638"/>
            <a:ext cx="6022508" cy="228006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087A5E6-B6E0-5F40-B5F7-9D0294EE539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108" r="43896"/>
          <a:stretch/>
        </p:blipFill>
        <p:spPr>
          <a:xfrm rot="5400000">
            <a:off x="7107835" y="1451440"/>
            <a:ext cx="2488954" cy="602250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CD38806-BFD1-CF46-8F96-5A1B32E28C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850164" y="1183019"/>
            <a:ext cx="3058838" cy="4070392"/>
          </a:xfrm>
          <a:prstGeom prst="rect">
            <a:avLst/>
          </a:prstGeom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1E1A7262-C642-1D4C-AE6A-88856AB01A4A}"/>
              </a:ext>
            </a:extLst>
          </p:cNvPr>
          <p:cNvCxnSpPr/>
          <p:nvPr/>
        </p:nvCxnSpPr>
        <p:spPr>
          <a:xfrm flipV="1">
            <a:off x="4191990" y="1688795"/>
            <a:ext cx="1021278" cy="72189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555424E2-8E4E-2C47-AA36-426497A2C90E}"/>
              </a:ext>
            </a:extLst>
          </p:cNvPr>
          <p:cNvCxnSpPr/>
          <p:nvPr/>
        </p:nvCxnSpPr>
        <p:spPr>
          <a:xfrm>
            <a:off x="4191990" y="2576945"/>
            <a:ext cx="1033153" cy="161504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58B05F72-B061-0F48-A478-B6161FCEC197}"/>
              </a:ext>
            </a:extLst>
          </p:cNvPr>
          <p:cNvSpPr txBox="1"/>
          <p:nvPr/>
        </p:nvSpPr>
        <p:spPr>
          <a:xfrm>
            <a:off x="6872771" y="112215"/>
            <a:ext cx="332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e blot removed from the paper</a:t>
            </a:r>
          </a:p>
        </p:txBody>
      </p:sp>
    </p:spTree>
    <p:extLst>
      <p:ext uri="{BB962C8B-B14F-4D97-AF65-F5344CB8AC3E}">
        <p14:creationId xmlns:p14="http://schemas.microsoft.com/office/powerpoint/2010/main" val="26039797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AEE2174-47CB-FC4B-95D1-0B8A7673FD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6334065" y="-1340285"/>
            <a:ext cx="3958084" cy="6858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42EB229-9109-BB43-8632-F32264A80B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7472600" y="1866378"/>
            <a:ext cx="1681014" cy="6858000"/>
          </a:xfrm>
          <a:prstGeom prst="rect">
            <a:avLst/>
          </a:prstGeom>
        </p:spPr>
      </p:pic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06D0522-2B71-DD4D-91F2-DE062658662E}"/>
              </a:ext>
            </a:extLst>
          </p:cNvPr>
          <p:cNvCxnSpPr/>
          <p:nvPr/>
        </p:nvCxnSpPr>
        <p:spPr>
          <a:xfrm>
            <a:off x="8517699" y="3607496"/>
            <a:ext cx="0" cy="1077238"/>
          </a:xfrm>
          <a:prstGeom prst="straightConnector1">
            <a:avLst/>
          </a:prstGeom>
          <a:ln w="38100"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BEC689DF-8975-B749-868E-B553414FCB7D}"/>
              </a:ext>
            </a:extLst>
          </p:cNvPr>
          <p:cNvSpPr txBox="1"/>
          <p:nvPr/>
        </p:nvSpPr>
        <p:spPr>
          <a:xfrm>
            <a:off x="501040" y="275573"/>
            <a:ext cx="20610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5A lower panel</a:t>
            </a:r>
          </a:p>
        </p:txBody>
      </p:sp>
      <p:pic>
        <p:nvPicPr>
          <p:cNvPr id="6" name="Picture 2">
            <a:extLst>
              <a:ext uri="{FF2B5EF4-FFF2-40B4-BE49-F238E27FC236}">
                <a16:creationId xmlns:a16="http://schemas.microsoft.com/office/drawing/2014/main" id="{AF6021C8-8D6A-6646-9481-CCB95385B67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476" r="46282" b="32624"/>
          <a:stretch/>
        </p:blipFill>
        <p:spPr bwMode="auto">
          <a:xfrm>
            <a:off x="0" y="1413704"/>
            <a:ext cx="3540917" cy="26540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538F6744-32F2-6B4C-81DD-1F75A6CEB9E3}"/>
              </a:ext>
            </a:extLst>
          </p:cNvPr>
          <p:cNvCxnSpPr>
            <a:cxnSpLocks/>
          </p:cNvCxnSpPr>
          <p:nvPr/>
        </p:nvCxnSpPr>
        <p:spPr>
          <a:xfrm>
            <a:off x="2778827" y="2897580"/>
            <a:ext cx="3788228" cy="2493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176E3614-C238-D84E-8E44-3692D6D5814D}"/>
              </a:ext>
            </a:extLst>
          </p:cNvPr>
          <p:cNvCxnSpPr>
            <a:cxnSpLocks/>
          </p:cNvCxnSpPr>
          <p:nvPr/>
        </p:nvCxnSpPr>
        <p:spPr>
          <a:xfrm flipV="1">
            <a:off x="2754280" y="1128507"/>
            <a:ext cx="3812775" cy="7822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C211D9F0-0CDC-DD4F-80AB-F4C712AF7395}"/>
              </a:ext>
            </a:extLst>
          </p:cNvPr>
          <p:cNvCxnSpPr>
            <a:cxnSpLocks/>
          </p:cNvCxnSpPr>
          <p:nvPr/>
        </p:nvCxnSpPr>
        <p:spPr>
          <a:xfrm flipV="1">
            <a:off x="2754280" y="2088714"/>
            <a:ext cx="3895902" cy="29219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3611946A-956A-214B-9B3A-B062571ABE50}"/>
              </a:ext>
            </a:extLst>
          </p:cNvPr>
          <p:cNvSpPr txBox="1"/>
          <p:nvPr/>
        </p:nvSpPr>
        <p:spPr>
          <a:xfrm>
            <a:off x="5532120" y="6229350"/>
            <a:ext cx="6080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nlarged image of the lowermost blot for anti-</a:t>
            </a:r>
            <a:r>
              <a:rPr lang="en-US" dirty="0">
                <a:latin typeface="Symbol" pitchFamily="2" charset="2"/>
              </a:rPr>
              <a:t>b</a:t>
            </a:r>
            <a:r>
              <a:rPr lang="en-US" dirty="0"/>
              <a:t>-catenin</a:t>
            </a:r>
          </a:p>
        </p:txBody>
      </p:sp>
    </p:spTree>
    <p:extLst>
      <p:ext uri="{BB962C8B-B14F-4D97-AF65-F5344CB8AC3E}">
        <p14:creationId xmlns:p14="http://schemas.microsoft.com/office/powerpoint/2010/main" val="16048814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948E036-DE87-A548-A7EE-DD437F24A5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37128" y="855210"/>
            <a:ext cx="5869897" cy="497565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6B3B77CA-E279-294D-BB3C-076C6A6B5E0C}"/>
              </a:ext>
            </a:extLst>
          </p:cNvPr>
          <p:cNvSpPr/>
          <p:nvPr/>
        </p:nvSpPr>
        <p:spPr>
          <a:xfrm rot="350693">
            <a:off x="6924639" y="2469264"/>
            <a:ext cx="3516093" cy="7562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35B61B-468A-2E4F-BF0B-DC3EC6B86298}"/>
              </a:ext>
            </a:extLst>
          </p:cNvPr>
          <p:cNvSpPr txBox="1"/>
          <p:nvPr/>
        </p:nvSpPr>
        <p:spPr>
          <a:xfrm>
            <a:off x="840183" y="372023"/>
            <a:ext cx="34316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5A lower panel- PCAF blot</a:t>
            </a:r>
          </a:p>
        </p:txBody>
      </p:sp>
      <p:pic>
        <p:nvPicPr>
          <p:cNvPr id="7" name="Picture 2">
            <a:extLst>
              <a:ext uri="{FF2B5EF4-FFF2-40B4-BE49-F238E27FC236}">
                <a16:creationId xmlns:a16="http://schemas.microsoft.com/office/drawing/2014/main" id="{F0C43777-8C1F-D745-8F15-B7CD0B030BA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476" r="46282" b="32624"/>
          <a:stretch/>
        </p:blipFill>
        <p:spPr bwMode="auto">
          <a:xfrm>
            <a:off x="1085998" y="1503856"/>
            <a:ext cx="3540917" cy="26540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F780F6DA-204B-7145-9853-03BAACB49ACD}"/>
              </a:ext>
            </a:extLst>
          </p:cNvPr>
          <p:cNvCxnSpPr>
            <a:cxnSpLocks/>
          </p:cNvCxnSpPr>
          <p:nvPr/>
        </p:nvCxnSpPr>
        <p:spPr>
          <a:xfrm flipV="1">
            <a:off x="3811183" y="2992582"/>
            <a:ext cx="3015503" cy="3393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895273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0736B1D-F629-5A4C-8A09-3ADD089AA3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6541503" y="560688"/>
            <a:ext cx="4164766" cy="5567521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4680EC81-4582-F949-996A-2DFD380107F6}"/>
              </a:ext>
            </a:extLst>
          </p:cNvPr>
          <p:cNvSpPr/>
          <p:nvPr/>
        </p:nvSpPr>
        <p:spPr>
          <a:xfrm rot="177362">
            <a:off x="6832069" y="3783141"/>
            <a:ext cx="3081403" cy="8006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7AB223-9A46-D349-8DD1-62C428D8D3B9}"/>
              </a:ext>
            </a:extLst>
          </p:cNvPr>
          <p:cNvSpPr txBox="1"/>
          <p:nvPr/>
        </p:nvSpPr>
        <p:spPr>
          <a:xfrm>
            <a:off x="488515" y="441286"/>
            <a:ext cx="40664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5A lower panel- </a:t>
            </a:r>
            <a:r>
              <a:rPr lang="en-US" sz="2400" dirty="0">
                <a:latin typeface="Symbol" pitchFamily="2" charset="2"/>
              </a:rPr>
              <a:t>b</a:t>
            </a:r>
            <a:r>
              <a:rPr lang="en-US" sz="2400" dirty="0"/>
              <a:t> tubulin blot</a:t>
            </a:r>
          </a:p>
        </p:txBody>
      </p:sp>
      <p:pic>
        <p:nvPicPr>
          <p:cNvPr id="8" name="Picture 2">
            <a:extLst>
              <a:ext uri="{FF2B5EF4-FFF2-40B4-BE49-F238E27FC236}">
                <a16:creationId xmlns:a16="http://schemas.microsoft.com/office/drawing/2014/main" id="{1F16255D-9C74-B14A-B76B-213BB0A5887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476" r="46282" b="32624"/>
          <a:stretch/>
        </p:blipFill>
        <p:spPr bwMode="auto">
          <a:xfrm>
            <a:off x="1093805" y="1867231"/>
            <a:ext cx="4004668" cy="30016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39AEB5B9-EDE9-A742-B92F-9A88CC04ECFE}"/>
              </a:ext>
            </a:extLst>
          </p:cNvPr>
          <p:cNvCxnSpPr>
            <a:cxnSpLocks/>
          </p:cNvCxnSpPr>
          <p:nvPr/>
        </p:nvCxnSpPr>
        <p:spPr>
          <a:xfrm flipV="1">
            <a:off x="4080248" y="4031672"/>
            <a:ext cx="2754245" cy="3523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93904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</Words>
  <Application>Microsoft Office PowerPoint</Application>
  <PresentationFormat>Widescreen</PresentationFormat>
  <Paragraphs>8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mple Notani</dc:creator>
  <cp:lastModifiedBy>Alice Coles-Aldridge</cp:lastModifiedBy>
  <cp:revision>8</cp:revision>
  <dcterms:created xsi:type="dcterms:W3CDTF">2021-12-03T08:44:01Z</dcterms:created>
  <dcterms:modified xsi:type="dcterms:W3CDTF">2022-06-20T11:12:58Z</dcterms:modified>
</cp:coreProperties>
</file>